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70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99913B3-5EB1-43D5-8D3D-79C38D0FD0C3}" v="10" dt="2023-01-17T11:48:20.268"/>
    <p1510:client id="{83F08A73-A3A9-4C81-AA4D-28954ECA25D8}" v="65" dt="2023-01-17T11:03:17.14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9631B5-78F2-41C9-869B-9F39066F8104}" styleName="中間スタイル 3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4C1A8A3-306A-4EB7-A6B1-4F7E0EB9C5D6}" styleName="中間スタイル 3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4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126" y="192"/>
      </p:cViewPr>
      <p:guideLst>
        <p:guide orient="horz" pos="216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wasaki Yoshihide" userId="f9b18687ebac7f3d" providerId="LiveId" clId="{099913B3-5EB1-43D5-8D3D-79C38D0FD0C3}"/>
    <pc:docChg chg="modSld">
      <pc:chgData name="Kawasaki Yoshihide" userId="f9b18687ebac7f3d" providerId="LiveId" clId="{099913B3-5EB1-43D5-8D3D-79C38D0FD0C3}" dt="2023-01-17T11:48:20.268" v="9" actId="207"/>
      <pc:docMkLst>
        <pc:docMk/>
      </pc:docMkLst>
      <pc:sldChg chg="modSp">
        <pc:chgData name="Kawasaki Yoshihide" userId="f9b18687ebac7f3d" providerId="LiveId" clId="{099913B3-5EB1-43D5-8D3D-79C38D0FD0C3}" dt="2023-01-17T11:47:41.572" v="1" actId="207"/>
        <pc:sldMkLst>
          <pc:docMk/>
          <pc:sldMk cId="1660767653" sldId="259"/>
        </pc:sldMkLst>
        <pc:spChg chg="mod">
          <ac:chgData name="Kawasaki Yoshihide" userId="f9b18687ebac7f3d" providerId="LiveId" clId="{099913B3-5EB1-43D5-8D3D-79C38D0FD0C3}" dt="2023-01-17T11:47:41.572" v="1" actId="207"/>
          <ac:spMkLst>
            <pc:docMk/>
            <pc:sldMk cId="1660767653" sldId="259"/>
            <ac:spMk id="6" creationId="{3943F493-A29B-42E7-96A3-9349C6138B6C}"/>
          </ac:spMkLst>
        </pc:spChg>
        <pc:spChg chg="mod">
          <ac:chgData name="Kawasaki Yoshihide" userId="f9b18687ebac7f3d" providerId="LiveId" clId="{099913B3-5EB1-43D5-8D3D-79C38D0FD0C3}" dt="2023-01-17T11:47:36.036" v="0" actId="207"/>
          <ac:spMkLst>
            <pc:docMk/>
            <pc:sldMk cId="1660767653" sldId="259"/>
            <ac:spMk id="14" creationId="{9A49DBEA-0B50-1353-A8B1-6200A70BF3FF}"/>
          </ac:spMkLst>
        </pc:spChg>
        <pc:spChg chg="mod">
          <ac:chgData name="Kawasaki Yoshihide" userId="f9b18687ebac7f3d" providerId="LiveId" clId="{099913B3-5EB1-43D5-8D3D-79C38D0FD0C3}" dt="2023-01-17T11:47:36.036" v="0" actId="207"/>
          <ac:spMkLst>
            <pc:docMk/>
            <pc:sldMk cId="1660767653" sldId="259"/>
            <ac:spMk id="15" creationId="{44043972-246C-E829-4D77-7A316120C8F2}"/>
          </ac:spMkLst>
        </pc:spChg>
        <pc:spChg chg="mod">
          <ac:chgData name="Kawasaki Yoshihide" userId="f9b18687ebac7f3d" providerId="LiveId" clId="{099913B3-5EB1-43D5-8D3D-79C38D0FD0C3}" dt="2023-01-17T11:47:36.036" v="0" actId="207"/>
          <ac:spMkLst>
            <pc:docMk/>
            <pc:sldMk cId="1660767653" sldId="259"/>
            <ac:spMk id="17" creationId="{76493B66-9F1D-C3B4-B3E8-9E5F48642F6B}"/>
          </ac:spMkLst>
        </pc:spChg>
        <pc:spChg chg="mod">
          <ac:chgData name="Kawasaki Yoshihide" userId="f9b18687ebac7f3d" providerId="LiveId" clId="{099913B3-5EB1-43D5-8D3D-79C38D0FD0C3}" dt="2023-01-17T11:47:36.036" v="0" actId="207"/>
          <ac:spMkLst>
            <pc:docMk/>
            <pc:sldMk cId="1660767653" sldId="259"/>
            <ac:spMk id="19" creationId="{2C17A189-5CC1-92E1-3586-918E1CB6311A}"/>
          </ac:spMkLst>
        </pc:spChg>
        <pc:spChg chg="mod">
          <ac:chgData name="Kawasaki Yoshihide" userId="f9b18687ebac7f3d" providerId="LiveId" clId="{099913B3-5EB1-43D5-8D3D-79C38D0FD0C3}" dt="2023-01-17T11:47:36.036" v="0" actId="207"/>
          <ac:spMkLst>
            <pc:docMk/>
            <pc:sldMk cId="1660767653" sldId="259"/>
            <ac:spMk id="21" creationId="{FDDB9D97-3A15-1017-24E5-B9CD2C729F95}"/>
          </ac:spMkLst>
        </pc:spChg>
        <pc:spChg chg="mod">
          <ac:chgData name="Kawasaki Yoshihide" userId="f9b18687ebac7f3d" providerId="LiveId" clId="{099913B3-5EB1-43D5-8D3D-79C38D0FD0C3}" dt="2023-01-17T11:47:36.036" v="0" actId="207"/>
          <ac:spMkLst>
            <pc:docMk/>
            <pc:sldMk cId="1660767653" sldId="259"/>
            <ac:spMk id="30" creationId="{32451680-2E09-526A-68DF-CB87376B6292}"/>
          </ac:spMkLst>
        </pc:spChg>
        <pc:grpChg chg="mod">
          <ac:chgData name="Kawasaki Yoshihide" userId="f9b18687ebac7f3d" providerId="LiveId" clId="{099913B3-5EB1-43D5-8D3D-79C38D0FD0C3}" dt="2023-01-17T11:47:36.036" v="0" actId="207"/>
          <ac:grpSpMkLst>
            <pc:docMk/>
            <pc:sldMk cId="1660767653" sldId="259"/>
            <ac:grpSpMk id="24" creationId="{92C2AA41-A32E-9794-0D71-6E233C264596}"/>
          </ac:grpSpMkLst>
        </pc:grpChg>
        <pc:picChg chg="mod">
          <ac:chgData name="Kawasaki Yoshihide" userId="f9b18687ebac7f3d" providerId="LiveId" clId="{099913B3-5EB1-43D5-8D3D-79C38D0FD0C3}" dt="2023-01-17T11:47:36.036" v="0" actId="207"/>
          <ac:picMkLst>
            <pc:docMk/>
            <pc:sldMk cId="1660767653" sldId="259"/>
            <ac:picMk id="5" creationId="{19849062-A253-424C-8FCB-5DEED4CAB5A6}"/>
          </ac:picMkLst>
        </pc:picChg>
      </pc:sldChg>
      <pc:sldChg chg="modSp">
        <pc:chgData name="Kawasaki Yoshihide" userId="f9b18687ebac7f3d" providerId="LiveId" clId="{099913B3-5EB1-43D5-8D3D-79C38D0FD0C3}" dt="2023-01-17T11:47:51.157" v="3" actId="207"/>
        <pc:sldMkLst>
          <pc:docMk/>
          <pc:sldMk cId="596051499" sldId="261"/>
        </pc:sldMkLst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3" creationId="{1881956E-8827-F81E-E3EF-F448DD707350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4" creationId="{B4110398-4FD1-F629-66BE-71F28BD3473E}"/>
          </ac:spMkLst>
        </pc:spChg>
        <pc:spChg chg="mod">
          <ac:chgData name="Kawasaki Yoshihide" userId="f9b18687ebac7f3d" providerId="LiveId" clId="{099913B3-5EB1-43D5-8D3D-79C38D0FD0C3}" dt="2023-01-17T11:47:51.157" v="3" actId="207"/>
          <ac:spMkLst>
            <pc:docMk/>
            <pc:sldMk cId="596051499" sldId="261"/>
            <ac:spMk id="7" creationId="{FF8BE90D-6C77-4B3E-A7A3-EEFC68CF6CBA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13" creationId="{488B3C7E-6BB4-84E9-2E33-3ADD9BF111ED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14" creationId="{DED071BF-408D-F6E5-1CB1-E8733C77D2B2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16" creationId="{8B835E8C-3C04-264A-37C9-2CBB5AB2B941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17" creationId="{B7F78DE2-6DD2-542F-117C-71698F156406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18" creationId="{DB34F828-154E-FBAB-6938-2356BD82208B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19" creationId="{65F6CD31-CA04-9C3B-025C-5B8D2A783774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20" creationId="{135D5BC9-0B11-B65C-6FE7-C7A764C55414}"/>
          </ac:spMkLst>
        </pc:spChg>
        <pc:spChg chg="mod">
          <ac:chgData name="Kawasaki Yoshihide" userId="f9b18687ebac7f3d" providerId="LiveId" clId="{099913B3-5EB1-43D5-8D3D-79C38D0FD0C3}" dt="2023-01-17T11:47:46.983" v="2" actId="207"/>
          <ac:spMkLst>
            <pc:docMk/>
            <pc:sldMk cId="596051499" sldId="261"/>
            <ac:spMk id="21" creationId="{E2CFF678-57CE-91D9-B531-CBAE1D6B5126}"/>
          </ac:spMkLst>
        </pc:spChg>
        <pc:grpChg chg="mod">
          <ac:chgData name="Kawasaki Yoshihide" userId="f9b18687ebac7f3d" providerId="LiveId" clId="{099913B3-5EB1-43D5-8D3D-79C38D0FD0C3}" dt="2023-01-17T11:47:46.983" v="2" actId="207"/>
          <ac:grpSpMkLst>
            <pc:docMk/>
            <pc:sldMk cId="596051499" sldId="261"/>
            <ac:grpSpMk id="8" creationId="{AB3A2B1E-804A-7FE3-44E4-F15D6BD70E47}"/>
          </ac:grpSpMkLst>
        </pc:grpChg>
        <pc:grpChg chg="mod">
          <ac:chgData name="Kawasaki Yoshihide" userId="f9b18687ebac7f3d" providerId="LiveId" clId="{099913B3-5EB1-43D5-8D3D-79C38D0FD0C3}" dt="2023-01-17T11:47:46.983" v="2" actId="207"/>
          <ac:grpSpMkLst>
            <pc:docMk/>
            <pc:sldMk cId="596051499" sldId="261"/>
            <ac:grpSpMk id="22" creationId="{A889F16E-2CDE-F5D0-A84F-2D24D64D9C64}"/>
          </ac:grpSpMkLst>
        </pc:grpChg>
        <pc:graphicFrameChg chg="mod">
          <ac:chgData name="Kawasaki Yoshihide" userId="f9b18687ebac7f3d" providerId="LiveId" clId="{099913B3-5EB1-43D5-8D3D-79C38D0FD0C3}" dt="2023-01-17T11:47:46.983" v="2" actId="207"/>
          <ac:graphicFrameMkLst>
            <pc:docMk/>
            <pc:sldMk cId="596051499" sldId="261"/>
            <ac:graphicFrameMk id="12" creationId="{A6610CFF-88A9-E7A8-B8C6-5D5F424DEE66}"/>
          </ac:graphicFrameMkLst>
        </pc:graphicFrameChg>
        <pc:graphicFrameChg chg="mod">
          <ac:chgData name="Kawasaki Yoshihide" userId="f9b18687ebac7f3d" providerId="LiveId" clId="{099913B3-5EB1-43D5-8D3D-79C38D0FD0C3}" dt="2023-01-17T11:47:46.983" v="2" actId="207"/>
          <ac:graphicFrameMkLst>
            <pc:docMk/>
            <pc:sldMk cId="596051499" sldId="261"/>
            <ac:graphicFrameMk id="15" creationId="{5E006D06-BF9D-49EC-76D9-1D2255389DFF}"/>
          </ac:graphicFrameMkLst>
        </pc:graphicFrameChg>
        <pc:picChg chg="mod">
          <ac:chgData name="Kawasaki Yoshihide" userId="f9b18687ebac7f3d" providerId="LiveId" clId="{099913B3-5EB1-43D5-8D3D-79C38D0FD0C3}" dt="2023-01-17T11:47:46.983" v="2" actId="207"/>
          <ac:picMkLst>
            <pc:docMk/>
            <pc:sldMk cId="596051499" sldId="261"/>
            <ac:picMk id="5" creationId="{E64DC57D-3205-45CF-B070-D90982E7BA9A}"/>
          </ac:picMkLst>
        </pc:picChg>
        <pc:picChg chg="mod">
          <ac:chgData name="Kawasaki Yoshihide" userId="f9b18687ebac7f3d" providerId="LiveId" clId="{099913B3-5EB1-43D5-8D3D-79C38D0FD0C3}" dt="2023-01-17T11:47:46.983" v="2" actId="207"/>
          <ac:picMkLst>
            <pc:docMk/>
            <pc:sldMk cId="596051499" sldId="261"/>
            <ac:picMk id="6" creationId="{F843CEB0-ADBF-4040-959A-B543A934A333}"/>
          </ac:picMkLst>
        </pc:picChg>
      </pc:sldChg>
      <pc:sldChg chg="modSp">
        <pc:chgData name="Kawasaki Yoshihide" userId="f9b18687ebac7f3d" providerId="LiveId" clId="{099913B3-5EB1-43D5-8D3D-79C38D0FD0C3}" dt="2023-01-17T11:48:06.920" v="7" actId="207"/>
        <pc:sldMkLst>
          <pc:docMk/>
          <pc:sldMk cId="2738783527" sldId="267"/>
        </pc:sldMkLst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2" creationId="{AF35AFD5-3159-44FF-A36C-2993884CCC02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8" creationId="{05408BC2-3321-461E-9FE0-BB53950C7A12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9" creationId="{CBA17EC3-5D05-409F-A031-8EAFA1DFA23D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11" creationId="{7B0ECA87-8787-4DC5-AC16-F6EE9F0E7C62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12" creationId="{CD769934-187C-4BAB-87D0-BC8114AAA8DE}"/>
          </ac:spMkLst>
        </pc:spChg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16" creationId="{8D5E58CD-102E-471E-072B-38027BF55712}"/>
          </ac:spMkLst>
        </pc:spChg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17" creationId="{76C3B18B-635A-367F-FCFB-47AD6F8F453E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18" creationId="{47DBAD07-A489-4FA4-BDD6-2E9EB59560E6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19" creationId="{595BD512-2268-4F1E-B01E-52D830B05024}"/>
          </ac:spMkLst>
        </pc:spChg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21" creationId="{7DE48714-BFE0-41F6-8A57-1A0FD6D64377}"/>
          </ac:spMkLst>
        </pc:spChg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29" creationId="{CE592CD5-6F31-6B25-3871-2E216C1B64D5}"/>
          </ac:spMkLst>
        </pc:spChg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30" creationId="{1EE832B1-9B44-FFA1-C976-FEF108F92125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31" creationId="{57329736-D158-8694-8D5C-E620353323BA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32" creationId="{69647B1D-08DD-3FD7-3202-CF509989313E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33" creationId="{701AE05E-F194-2D9F-1CAD-F08D32C67FAF}"/>
          </ac:spMkLst>
        </pc:spChg>
        <pc:spChg chg="mod">
          <ac:chgData name="Kawasaki Yoshihide" userId="f9b18687ebac7f3d" providerId="LiveId" clId="{099913B3-5EB1-43D5-8D3D-79C38D0FD0C3}" dt="2023-01-17T11:48:06.920" v="7" actId="207"/>
          <ac:spMkLst>
            <pc:docMk/>
            <pc:sldMk cId="2738783527" sldId="267"/>
            <ac:spMk id="34" creationId="{1ED6B258-E6A3-4F8E-B6FA-0ABD22C50A02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35" creationId="{0A82ED94-6457-E199-2288-778198A2336A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36" creationId="{1E6F1986-D2A6-6AFC-6777-4DF5E206E201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45" creationId="{BFA00D88-276B-4874-0F3C-3C3AD3F78FC9}"/>
          </ac:spMkLst>
        </pc:spChg>
        <pc:spChg chg="mod">
          <ac:chgData name="Kawasaki Yoshihide" userId="f9b18687ebac7f3d" providerId="LiveId" clId="{099913B3-5EB1-43D5-8D3D-79C38D0FD0C3}" dt="2023-01-17T11:47:59.688" v="5" actId="207"/>
          <ac:spMkLst>
            <pc:docMk/>
            <pc:sldMk cId="2738783527" sldId="267"/>
            <ac:spMk id="46" creationId="{A59BDF08-09FC-5146-D464-4F24205ED183}"/>
          </ac:spMkLst>
        </pc:spChg>
        <pc:grpChg chg="mod">
          <ac:chgData name="Kawasaki Yoshihide" userId="f9b18687ebac7f3d" providerId="LiveId" clId="{099913B3-5EB1-43D5-8D3D-79C38D0FD0C3}" dt="2023-01-17T11:48:06.920" v="7" actId="207"/>
          <ac:grpSpMkLst>
            <pc:docMk/>
            <pc:sldMk cId="2738783527" sldId="267"/>
            <ac:grpSpMk id="20" creationId="{EB8E9A54-C6AF-43DB-9910-5BA39ED355B2}"/>
          </ac:grpSpMkLst>
        </pc:grpChg>
        <pc:grpChg chg="mod">
          <ac:chgData name="Kawasaki Yoshihide" userId="f9b18687ebac7f3d" providerId="LiveId" clId="{099913B3-5EB1-43D5-8D3D-79C38D0FD0C3}" dt="2023-01-17T11:47:59.688" v="5" actId="207"/>
          <ac:grpSpMkLst>
            <pc:docMk/>
            <pc:sldMk cId="2738783527" sldId="267"/>
            <ac:grpSpMk id="25" creationId="{ADFE97EB-D9C5-4A85-AE95-D0C841F03B41}"/>
          </ac:grpSpMkLst>
        </pc:grpChg>
        <pc:grpChg chg="mod">
          <ac:chgData name="Kawasaki Yoshihide" userId="f9b18687ebac7f3d" providerId="LiveId" clId="{099913B3-5EB1-43D5-8D3D-79C38D0FD0C3}" dt="2023-01-17T11:47:59.688" v="5" actId="207"/>
          <ac:grpSpMkLst>
            <pc:docMk/>
            <pc:sldMk cId="2738783527" sldId="267"/>
            <ac:grpSpMk id="37" creationId="{F7430A5E-5D12-868A-9568-27264394E667}"/>
          </ac:grpSpMkLst>
        </pc:grpChg>
        <pc:grpChg chg="mod">
          <ac:chgData name="Kawasaki Yoshihide" userId="f9b18687ebac7f3d" providerId="LiveId" clId="{099913B3-5EB1-43D5-8D3D-79C38D0FD0C3}" dt="2023-01-17T11:47:59.688" v="5" actId="207"/>
          <ac:grpSpMkLst>
            <pc:docMk/>
            <pc:sldMk cId="2738783527" sldId="267"/>
            <ac:grpSpMk id="41" creationId="{AC566922-9075-99A7-1D96-1D44BAE0DC48}"/>
          </ac:grpSpMkLst>
        </pc:grpChg>
        <pc:graphicFrameChg chg="mod">
          <ac:chgData name="Kawasaki Yoshihide" userId="f9b18687ebac7f3d" providerId="LiveId" clId="{099913B3-5EB1-43D5-8D3D-79C38D0FD0C3}" dt="2023-01-17T11:47:59.688" v="5" actId="207"/>
          <ac:graphicFrameMkLst>
            <pc:docMk/>
            <pc:sldMk cId="2738783527" sldId="267"/>
            <ac:graphicFrameMk id="3" creationId="{83AAEAEA-DF31-F93D-1369-94FB8497072F}"/>
          </ac:graphicFrameMkLst>
        </pc:graphicFrameChg>
        <pc:graphicFrameChg chg="mod">
          <ac:chgData name="Kawasaki Yoshihide" userId="f9b18687ebac7f3d" providerId="LiveId" clId="{099913B3-5EB1-43D5-8D3D-79C38D0FD0C3}" dt="2023-01-17T11:47:59.688" v="5" actId="207"/>
          <ac:graphicFrameMkLst>
            <pc:docMk/>
            <pc:sldMk cId="2738783527" sldId="267"/>
            <ac:graphicFrameMk id="5" creationId="{B06E9F51-8456-26C8-F26E-CA01BC281528}"/>
          </ac:graphicFrameMkLst>
        </pc:graphicFrameChg>
        <pc:graphicFrameChg chg="mod">
          <ac:chgData name="Kawasaki Yoshihide" userId="f9b18687ebac7f3d" providerId="LiveId" clId="{099913B3-5EB1-43D5-8D3D-79C38D0FD0C3}" dt="2023-01-17T11:47:59.688" v="5" actId="207"/>
          <ac:graphicFrameMkLst>
            <pc:docMk/>
            <pc:sldMk cId="2738783527" sldId="267"/>
            <ac:graphicFrameMk id="13" creationId="{924B4E15-2217-8B65-F502-4A3A479C8B1C}"/>
          </ac:graphicFrameMkLst>
        </pc:graphicFrameChg>
        <pc:graphicFrameChg chg="mod">
          <ac:chgData name="Kawasaki Yoshihide" userId="f9b18687ebac7f3d" providerId="LiveId" clId="{099913B3-5EB1-43D5-8D3D-79C38D0FD0C3}" dt="2023-01-17T11:47:59.688" v="5" actId="207"/>
          <ac:graphicFrameMkLst>
            <pc:docMk/>
            <pc:sldMk cId="2738783527" sldId="267"/>
            <ac:graphicFrameMk id="14" creationId="{E698257B-4DEE-0EAD-F6E9-82A65CE0AABC}"/>
          </ac:graphicFrameMkLst>
        </pc:graphicFrameChg>
        <pc:picChg chg="mod">
          <ac:chgData name="Kawasaki Yoshihide" userId="f9b18687ebac7f3d" providerId="LiveId" clId="{099913B3-5EB1-43D5-8D3D-79C38D0FD0C3}" dt="2023-01-17T11:47:59.688" v="5" actId="207"/>
          <ac:picMkLst>
            <pc:docMk/>
            <pc:sldMk cId="2738783527" sldId="267"/>
            <ac:picMk id="4" creationId="{9FD53516-E442-4B5A-969E-4744D20AF10B}"/>
          </ac:picMkLst>
        </pc:picChg>
        <pc:picChg chg="mod">
          <ac:chgData name="Kawasaki Yoshihide" userId="f9b18687ebac7f3d" providerId="LiveId" clId="{099913B3-5EB1-43D5-8D3D-79C38D0FD0C3}" dt="2023-01-17T11:47:59.688" v="5" actId="207"/>
          <ac:picMkLst>
            <pc:docMk/>
            <pc:sldMk cId="2738783527" sldId="267"/>
            <ac:picMk id="6" creationId="{A7905399-9712-4C75-A8F6-920992A62FF3}"/>
          </ac:picMkLst>
        </pc:picChg>
        <pc:picChg chg="mod">
          <ac:chgData name="Kawasaki Yoshihide" userId="f9b18687ebac7f3d" providerId="LiveId" clId="{099913B3-5EB1-43D5-8D3D-79C38D0FD0C3}" dt="2023-01-17T11:47:59.688" v="5" actId="207"/>
          <ac:picMkLst>
            <pc:docMk/>
            <pc:sldMk cId="2738783527" sldId="267"/>
            <ac:picMk id="10" creationId="{14EB2290-A8AA-4C2E-92C4-C363C09F6498}"/>
          </ac:picMkLst>
        </pc:picChg>
        <pc:picChg chg="mod">
          <ac:chgData name="Kawasaki Yoshihide" userId="f9b18687ebac7f3d" providerId="LiveId" clId="{099913B3-5EB1-43D5-8D3D-79C38D0FD0C3}" dt="2023-01-17T11:48:06.920" v="7" actId="207"/>
          <ac:picMkLst>
            <pc:docMk/>
            <pc:sldMk cId="2738783527" sldId="267"/>
            <ac:picMk id="15" creationId="{3E532259-B035-4A34-BA13-2EBBB79F741A}"/>
          </ac:picMkLst>
        </pc:picChg>
      </pc:sldChg>
      <pc:sldChg chg="modSp">
        <pc:chgData name="Kawasaki Yoshihide" userId="f9b18687ebac7f3d" providerId="LiveId" clId="{099913B3-5EB1-43D5-8D3D-79C38D0FD0C3}" dt="2023-01-17T11:48:20.268" v="9" actId="207"/>
        <pc:sldMkLst>
          <pc:docMk/>
          <pc:sldMk cId="0" sldId="705"/>
        </pc:sldMkLst>
        <pc:spChg chg="mod">
          <ac:chgData name="Kawasaki Yoshihide" userId="f9b18687ebac7f3d" providerId="LiveId" clId="{099913B3-5EB1-43D5-8D3D-79C38D0FD0C3}" dt="2023-01-17T11:48:20.268" v="9" actId="207"/>
          <ac:spMkLst>
            <pc:docMk/>
            <pc:sldMk cId="0" sldId="705"/>
            <ac:spMk id="16390" creationId="{DD81B7F8-4185-4843-98E9-F72744CB173F}"/>
          </ac:spMkLst>
        </pc:spChg>
      </pc:sldChg>
      <pc:sldChg chg="modSp">
        <pc:chgData name="Kawasaki Yoshihide" userId="f9b18687ebac7f3d" providerId="LiveId" clId="{099913B3-5EB1-43D5-8D3D-79C38D0FD0C3}" dt="2023-01-17T11:48:15.057" v="8" actId="207"/>
        <pc:sldMkLst>
          <pc:docMk/>
          <pc:sldMk cId="1553013521" sldId="711"/>
        </pc:sldMkLst>
        <pc:spChg chg="mod">
          <ac:chgData name="Kawasaki Yoshihide" userId="f9b18687ebac7f3d" providerId="LiveId" clId="{099913B3-5EB1-43D5-8D3D-79C38D0FD0C3}" dt="2023-01-17T11:48:15.057" v="8" actId="207"/>
          <ac:spMkLst>
            <pc:docMk/>
            <pc:sldMk cId="1553013521" sldId="711"/>
            <ac:spMk id="7" creationId="{60DE9C8D-A9DC-F7FB-C82D-F97E8DF6DA22}"/>
          </ac:spMkLst>
        </pc:spChg>
        <pc:spChg chg="mod">
          <ac:chgData name="Kawasaki Yoshihide" userId="f9b18687ebac7f3d" providerId="LiveId" clId="{099913B3-5EB1-43D5-8D3D-79C38D0FD0C3}" dt="2023-01-17T11:48:15.057" v="8" actId="207"/>
          <ac:spMkLst>
            <pc:docMk/>
            <pc:sldMk cId="1553013521" sldId="711"/>
            <ac:spMk id="8" creationId="{AA62F658-E894-CAA0-2EAE-E8DE40DAE7E5}"/>
          </ac:spMkLst>
        </pc:spChg>
        <pc:spChg chg="mod">
          <ac:chgData name="Kawasaki Yoshihide" userId="f9b18687ebac7f3d" providerId="LiveId" clId="{099913B3-5EB1-43D5-8D3D-79C38D0FD0C3}" dt="2023-01-17T11:48:15.057" v="8" actId="207"/>
          <ac:spMkLst>
            <pc:docMk/>
            <pc:sldMk cId="1553013521" sldId="711"/>
            <ac:spMk id="12" creationId="{F61D6535-2B06-8886-2DC1-D7AFDF95DC04}"/>
          </ac:spMkLst>
        </pc:spChg>
        <pc:spChg chg="mod">
          <ac:chgData name="Kawasaki Yoshihide" userId="f9b18687ebac7f3d" providerId="LiveId" clId="{099913B3-5EB1-43D5-8D3D-79C38D0FD0C3}" dt="2023-01-17T11:48:15.057" v="8" actId="207"/>
          <ac:spMkLst>
            <pc:docMk/>
            <pc:sldMk cId="1553013521" sldId="711"/>
            <ac:spMk id="27" creationId="{63C4E9BA-946D-7983-9F51-DC7932A78088}"/>
          </ac:spMkLst>
        </pc:spChg>
        <pc:spChg chg="mod">
          <ac:chgData name="Kawasaki Yoshihide" userId="f9b18687ebac7f3d" providerId="LiveId" clId="{099913B3-5EB1-43D5-8D3D-79C38D0FD0C3}" dt="2023-01-17T11:48:15.057" v="8" actId="207"/>
          <ac:spMkLst>
            <pc:docMk/>
            <pc:sldMk cId="1553013521" sldId="711"/>
            <ac:spMk id="30" creationId="{3E73D906-70C9-0CD1-2C95-3EB5768DF6E7}"/>
          </ac:spMkLst>
        </pc:spChg>
        <pc:graphicFrameChg chg="mod">
          <ac:chgData name="Kawasaki Yoshihide" userId="f9b18687ebac7f3d" providerId="LiveId" clId="{099913B3-5EB1-43D5-8D3D-79C38D0FD0C3}" dt="2023-01-17T11:48:15.057" v="8" actId="207"/>
          <ac:graphicFrameMkLst>
            <pc:docMk/>
            <pc:sldMk cId="1553013521" sldId="711"/>
            <ac:graphicFrameMk id="15" creationId="{1CD95BB6-C028-D354-9460-5DAFA1FB4673}"/>
          </ac:graphicFrameMkLst>
        </pc:graphicFrameChg>
        <pc:graphicFrameChg chg="mod">
          <ac:chgData name="Kawasaki Yoshihide" userId="f9b18687ebac7f3d" providerId="LiveId" clId="{099913B3-5EB1-43D5-8D3D-79C38D0FD0C3}" dt="2023-01-17T11:48:15.057" v="8" actId="207"/>
          <ac:graphicFrameMkLst>
            <pc:docMk/>
            <pc:sldMk cId="1553013521" sldId="711"/>
            <ac:graphicFrameMk id="16" creationId="{999A3FC9-3ED5-EDD6-B24E-6C31B037EC0B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9964ED-24D5-4F99-9A13-2E782CBEFB0D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7C2F81-5C31-4BE2-9E79-91431E7D95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913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064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414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930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121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910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205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5459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003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6820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779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97063-724F-4F66-B614-B1F9A2ED0474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983AF0-EBA9-4083-8B27-4333256189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8800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タイトル 1">
            <a:extLst>
              <a:ext uri="{FF2B5EF4-FFF2-40B4-BE49-F238E27FC236}">
                <a16:creationId xmlns:a16="http://schemas.microsoft.com/office/drawing/2014/main" xmlns="" id="{2789B8DF-3977-4CA1-86C5-182A42B1C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609" y="160293"/>
            <a:ext cx="8917757" cy="848430"/>
          </a:xfrm>
        </p:spPr>
        <p:txBody>
          <a:bodyPr>
            <a:normAutofit/>
          </a:bodyPr>
          <a:lstStyle/>
          <a:p>
            <a:pPr algn="ctr"/>
            <a:r>
              <a:rPr lang="en-US" altLang="ja-JP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Thirteen regional hospitals and Tohoku University Hospital</a:t>
            </a:r>
            <a:br>
              <a:rPr lang="en-US" altLang="ja-JP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</a:br>
            <a:r>
              <a:rPr lang="en-US" altLang="ja-JP" sz="20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 in the east northern region of Japan</a:t>
            </a:r>
            <a:endParaRPr lang="ja-JP" altLang="en-US" sz="2000" dirty="0">
              <a:solidFill>
                <a:srgbClr val="0070C0"/>
              </a:solidFill>
              <a:latin typeface="HG丸ｺﾞｼｯｸM-PRO" panose="020F0600000000000000" pitchFamily="50" charset="-128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390" name="正方形/長方形 1">
            <a:extLst>
              <a:ext uri="{FF2B5EF4-FFF2-40B4-BE49-F238E27FC236}">
                <a16:creationId xmlns:a16="http://schemas.microsoft.com/office/drawing/2014/main" xmlns="" id="{DD81B7F8-4185-4843-98E9-F72744CB17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5133" y="6513041"/>
            <a:ext cx="226658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kumimoji="1" sz="21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5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 sz="1300">
                <a:solidFill>
                  <a:schemeClr val="tx1"/>
                </a:solidFill>
                <a:latin typeface="游ゴシック" panose="020B0400000000000000" pitchFamily="50" charset="-128"/>
                <a:ea typeface="游ゴシック" panose="020B0400000000000000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 dirty="0">
                <a:latin typeface="Calibri" panose="020F0502020204030204" pitchFamily="34" charset="0"/>
              </a:rPr>
              <a:t>Supplementary figure </a:t>
            </a: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xmlns="" id="{1F66D2DC-5364-4C90-B85B-8AC75FAB9A67}"/>
              </a:ext>
            </a:extLst>
          </p:cNvPr>
          <p:cNvCxnSpPr>
            <a:cxnSpLocks/>
            <a:endCxn id="16391" idx="3"/>
          </p:cNvCxnSpPr>
          <p:nvPr/>
        </p:nvCxnSpPr>
        <p:spPr bwMode="auto">
          <a:xfrm flipH="1" flipV="1">
            <a:off x="4427537" y="1332320"/>
            <a:ext cx="504826" cy="26781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xmlns="" id="{237F790C-36E6-6D81-EB85-2FE2F9013637}"/>
              </a:ext>
            </a:extLst>
          </p:cNvPr>
          <p:cNvCxnSpPr>
            <a:cxnSpLocks/>
            <a:stCxn id="42" idx="1"/>
          </p:cNvCxnSpPr>
          <p:nvPr/>
        </p:nvCxnSpPr>
        <p:spPr bwMode="auto">
          <a:xfrm flipH="1" flipV="1">
            <a:off x="4891925" y="4113646"/>
            <a:ext cx="555445" cy="80964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D0EB8D6B-472A-50A5-5E22-147649D0FBF0}"/>
              </a:ext>
            </a:extLst>
          </p:cNvPr>
          <p:cNvGrpSpPr/>
          <p:nvPr/>
        </p:nvGrpSpPr>
        <p:grpSpPr>
          <a:xfrm>
            <a:off x="79375" y="1110095"/>
            <a:ext cx="8912225" cy="4437063"/>
            <a:chOff x="88900" y="1581150"/>
            <a:chExt cx="8912225" cy="4437063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xmlns="" id="{1A5096A1-CBA1-274F-9DE0-FC239AE504F5}"/>
                </a:ext>
              </a:extLst>
            </p:cNvPr>
            <p:cNvGrpSpPr/>
            <p:nvPr/>
          </p:nvGrpSpPr>
          <p:grpSpPr>
            <a:xfrm>
              <a:off x="88900" y="1581150"/>
              <a:ext cx="8912225" cy="4437063"/>
              <a:chOff x="88900" y="1581150"/>
              <a:chExt cx="8912225" cy="4437063"/>
            </a:xfrm>
          </p:grpSpPr>
          <p:grpSp>
            <p:nvGrpSpPr>
              <p:cNvPr id="16387" name="グループ化 7">
                <a:extLst>
                  <a:ext uri="{FF2B5EF4-FFF2-40B4-BE49-F238E27FC236}">
                    <a16:creationId xmlns:a16="http://schemas.microsoft.com/office/drawing/2014/main" xmlns="" id="{2AF37518-E255-444A-B002-F23AC3883A41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88900" y="1581150"/>
                <a:ext cx="8912225" cy="4437063"/>
                <a:chOff x="-181988" y="2652028"/>
                <a:chExt cx="8912241" cy="4437052"/>
              </a:xfrm>
            </p:grpSpPr>
            <p:grpSp>
              <p:nvGrpSpPr>
                <p:cNvPr id="16393" name="グループ化 9238">
                  <a:extLst>
                    <a:ext uri="{FF2B5EF4-FFF2-40B4-BE49-F238E27FC236}">
                      <a16:creationId xmlns:a16="http://schemas.microsoft.com/office/drawing/2014/main" xmlns="" id="{1DD8203D-A95E-4DE4-8AFB-19968403383F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-181988" y="2652028"/>
                  <a:ext cx="8912241" cy="4437052"/>
                  <a:chOff x="-403368" y="2651339"/>
                  <a:chExt cx="8911062" cy="4437052"/>
                </a:xfrm>
              </p:grpSpPr>
              <p:pic>
                <p:nvPicPr>
                  <p:cNvPr id="16396" name="図 1">
                    <a:extLst>
                      <a:ext uri="{FF2B5EF4-FFF2-40B4-BE49-F238E27FC236}">
                        <a16:creationId xmlns:a16="http://schemas.microsoft.com/office/drawing/2014/main" xmlns="" id="{A4BE5A27-B58F-4939-AFBD-D54BCDCED9B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168975" y="2651339"/>
                    <a:ext cx="2246608" cy="44370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grpSp>
                <p:nvGrpSpPr>
                  <p:cNvPr id="16397" name="グループ化 9237">
                    <a:extLst>
                      <a:ext uri="{FF2B5EF4-FFF2-40B4-BE49-F238E27FC236}">
                        <a16:creationId xmlns:a16="http://schemas.microsoft.com/office/drawing/2014/main" xmlns="" id="{069139C9-8103-401C-BA9E-DC4EED592A2E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-403368" y="3484783"/>
                    <a:ext cx="8911062" cy="3211496"/>
                    <a:chOff x="-403368" y="3484783"/>
                    <a:chExt cx="8911062" cy="3211496"/>
                  </a:xfrm>
                </p:grpSpPr>
                <p:sp>
                  <p:nvSpPr>
                    <p:cNvPr id="16398" name="正方形/長方形 4">
                      <a:extLst>
                        <a:ext uri="{FF2B5EF4-FFF2-40B4-BE49-F238E27FC236}">
                          <a16:creationId xmlns:a16="http://schemas.microsoft.com/office/drawing/2014/main" xmlns="" id="{E3D3EBC6-9E1C-4629-8761-65412008CF9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19643" y="3484783"/>
                      <a:ext cx="2646855" cy="3416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buChar char="•"/>
                        <a:defRPr kumimoji="1" sz="21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5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9pPr>
                    </a:lstStyle>
                    <a:p>
                      <a:pPr eaLnBrk="1" hangingPunct="1">
                        <a:buFontTx/>
                        <a:buNone/>
                      </a:pPr>
                      <a:r>
                        <a:rPr lang="en-US" altLang="ja-JP" sz="18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Hachinohe City Hospital</a:t>
                      </a:r>
                    </a:p>
                  </p:txBody>
                </p:sp>
                <p:sp>
                  <p:nvSpPr>
                    <p:cNvPr id="16399" name="正方形/長方形 5">
                      <a:extLst>
                        <a:ext uri="{FF2B5EF4-FFF2-40B4-BE49-F238E27FC236}">
                          <a16:creationId xmlns:a16="http://schemas.microsoft.com/office/drawing/2014/main" xmlns="" id="{10D3C389-0D21-46E1-997C-F57E10B532E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38752" y="5745246"/>
                      <a:ext cx="2416025" cy="3416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buChar char="•"/>
                        <a:defRPr kumimoji="1" sz="21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5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9pPr>
                    </a:lstStyle>
                    <a:p>
                      <a:pPr eaLnBrk="1" hangingPunct="1">
                        <a:buFontTx/>
                        <a:buNone/>
                      </a:pPr>
                      <a:r>
                        <a:rPr lang="en-US" altLang="ja-JP" sz="18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Miyagi Cancer Center</a:t>
                      </a:r>
                    </a:p>
                  </p:txBody>
                </p:sp>
                <p:sp>
                  <p:nvSpPr>
                    <p:cNvPr id="16400" name="正方形/長方形 6">
                      <a:extLst>
                        <a:ext uri="{FF2B5EF4-FFF2-40B4-BE49-F238E27FC236}">
                          <a16:creationId xmlns:a16="http://schemas.microsoft.com/office/drawing/2014/main" xmlns="" id="{B432B77C-8FAD-448F-8129-7A508A2F4C3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190347" y="5793076"/>
                      <a:ext cx="2480209" cy="3693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r>
                        <a:rPr lang="en-US" altLang="ja-JP" sz="1800">
                          <a:solidFill>
                            <a:srgbClr val="000000"/>
                          </a:solidFill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Tohoku Rosai Hospital</a:t>
                      </a:r>
                      <a:endParaRPr lang="ja-JP" altLang="en-US" sz="1800">
                        <a:ea typeface="HG丸ｺﾞｼｯｸM-PRO" panose="020F06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401" name="正方形/長方形 7">
                      <a:extLst>
                        <a:ext uri="{FF2B5EF4-FFF2-40B4-BE49-F238E27FC236}">
                          <a16:creationId xmlns:a16="http://schemas.microsoft.com/office/drawing/2014/main" xmlns="" id="{7DE52D84-036A-4883-B8FE-4FCD4B7E4E4E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95230" y="4261910"/>
                      <a:ext cx="2954629" cy="3693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r>
                        <a:rPr lang="en-US" altLang="ja-JP" sz="1800">
                          <a:solidFill>
                            <a:srgbClr val="000000"/>
                          </a:solidFill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Sendai Red Cross Hospital</a:t>
                      </a:r>
                      <a:endParaRPr lang="ja-JP" altLang="en-US" sz="1800">
                        <a:ea typeface="HG丸ｺﾞｼｯｸM-PRO" panose="020F06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402" name="正方形/長方形 8">
                      <a:extLst>
                        <a:ext uri="{FF2B5EF4-FFF2-40B4-BE49-F238E27FC236}">
                          <a16:creationId xmlns:a16="http://schemas.microsoft.com/office/drawing/2014/main" xmlns="" id="{C3E5B71B-0CF6-45F3-8470-E28C614DD1F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76312" y="3800389"/>
                      <a:ext cx="2492967" cy="3693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r>
                        <a:rPr lang="en-US" altLang="ja-JP" sz="1800">
                          <a:solidFill>
                            <a:srgbClr val="000000"/>
                          </a:solidFill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JCHO Sendai Hospital</a:t>
                      </a:r>
                      <a:endParaRPr lang="ja-JP" altLang="en-US" sz="1800">
                        <a:ea typeface="HG丸ｺﾞｼｯｸM-PRO" panose="020F06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403" name="正方形/長方形 9">
                      <a:extLst>
                        <a:ext uri="{FF2B5EF4-FFF2-40B4-BE49-F238E27FC236}">
                          <a16:creationId xmlns:a16="http://schemas.microsoft.com/office/drawing/2014/main" xmlns="" id="{9EA7BC0B-6D8B-4772-A540-EF3F685BBF3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00598" y="4760627"/>
                      <a:ext cx="2262138" cy="3693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r>
                        <a:rPr lang="en-US" altLang="ja-JP" sz="1800">
                          <a:solidFill>
                            <a:srgbClr val="000000"/>
                          </a:solidFill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Sendai City Hospital</a:t>
                      </a:r>
                      <a:endParaRPr lang="ja-JP" altLang="en-US" sz="1800">
                        <a:ea typeface="HG丸ｺﾞｼｯｸM-PRO" panose="020F06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405" name="正方形/長方形 11">
                      <a:extLst>
                        <a:ext uri="{FF2B5EF4-FFF2-40B4-BE49-F238E27FC236}">
                          <a16:creationId xmlns:a16="http://schemas.microsoft.com/office/drawing/2014/main" xmlns="" id="{4F630E8B-2FD6-4697-A1F3-4E99A2157D3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-346461" y="5257925"/>
                      <a:ext cx="4104486" cy="3416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buChar char="•"/>
                        <a:defRPr kumimoji="1" sz="21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5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9pPr>
                    </a:lstStyle>
                    <a:p>
                      <a:pPr eaLnBrk="1" hangingPunct="1">
                        <a:buFontTx/>
                        <a:buNone/>
                      </a:pPr>
                      <a:r>
                        <a:rPr lang="en-US" altLang="ja-JP" sz="18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Yamagata Prefectural Central Hospital</a:t>
                      </a:r>
                    </a:p>
                  </p:txBody>
                </p:sp>
                <p:sp>
                  <p:nvSpPr>
                    <p:cNvPr id="16406" name="正方形/長方形 12">
                      <a:extLst>
                        <a:ext uri="{FF2B5EF4-FFF2-40B4-BE49-F238E27FC236}">
                          <a16:creationId xmlns:a16="http://schemas.microsoft.com/office/drawing/2014/main" xmlns="" id="{E84B314E-1D1B-426A-B35B-014B28437C0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-403368" y="6148959"/>
                      <a:ext cx="3685143" cy="34163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buChar char="•"/>
                        <a:defRPr kumimoji="1" sz="21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5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9pPr>
                    </a:lstStyle>
                    <a:p>
                      <a:pPr eaLnBrk="1" hangingPunct="1">
                        <a:buFontTx/>
                        <a:buNone/>
                      </a:pPr>
                      <a:r>
                        <a:rPr lang="en-US" altLang="ja-JP" sz="1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Shirakawa Kosei General Hospital</a:t>
                      </a:r>
                    </a:p>
                  </p:txBody>
                </p:sp>
                <p:sp>
                  <p:nvSpPr>
                    <p:cNvPr id="16407" name="正方形/長方形 13">
                      <a:extLst>
                        <a:ext uri="{FF2B5EF4-FFF2-40B4-BE49-F238E27FC236}">
                          <a16:creationId xmlns:a16="http://schemas.microsoft.com/office/drawing/2014/main" xmlns="" id="{4D7A2DBE-AAF5-4957-B748-7F5A44D8AE61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19643" y="4059683"/>
                      <a:ext cx="3288051" cy="3416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defTabSz="685800">
                        <a:lnSpc>
                          <a:spcPct val="90000"/>
                        </a:lnSpc>
                        <a:spcBef>
                          <a:spcPts val="750"/>
                        </a:spcBef>
                        <a:buFont typeface="Arial" panose="020B0604020202020204" pitchFamily="34" charset="0"/>
                        <a:buChar char="•"/>
                        <a:defRPr kumimoji="1" sz="21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1pPr>
                      <a:lvl2pPr marL="742950" indent="-28575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2pPr>
                      <a:lvl3pPr marL="11430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5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3pPr>
                      <a:lvl4pPr marL="16002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4pPr>
                      <a:lvl5pPr marL="2057400" indent="-228600" defTabSz="685800">
                        <a:lnSpc>
                          <a:spcPct val="90000"/>
                        </a:lnSpc>
                        <a:spcBef>
                          <a:spcPts val="375"/>
                        </a:spcBef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5pPr>
                      <a:lvl6pPr marL="25146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6pPr>
                      <a:lvl7pPr marL="29718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7pPr>
                      <a:lvl8pPr marL="34290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8pPr>
                      <a:lvl9pPr marL="3886200" indent="-228600" defTabSz="685800" eaLnBrk="0" fontAlgn="base" hangingPunct="0">
                        <a:lnSpc>
                          <a:spcPct val="90000"/>
                        </a:lnSpc>
                        <a:spcBef>
                          <a:spcPts val="375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 kumimoji="1" sz="1300">
                          <a:solidFill>
                            <a:schemeClr val="tx1"/>
                          </a:solidFill>
                          <a:latin typeface="游ゴシック" panose="020B0400000000000000" pitchFamily="50" charset="-128"/>
                          <a:ea typeface="游ゴシック" panose="020B0400000000000000" pitchFamily="50" charset="-128"/>
                        </a:defRPr>
                      </a:lvl9pPr>
                    </a:lstStyle>
                    <a:p>
                      <a:pPr eaLnBrk="1" hangingPunct="1">
                        <a:buFontTx/>
                        <a:buNone/>
                      </a:pPr>
                      <a:r>
                        <a:rPr lang="en-US" altLang="ja-JP" sz="18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Iwate Prefectural Iwai Hospital</a:t>
                      </a:r>
                    </a:p>
                  </p:txBody>
                </p:sp>
                <p:sp>
                  <p:nvSpPr>
                    <p:cNvPr id="16408" name="正方形/長方形 14">
                      <a:extLst>
                        <a:ext uri="{FF2B5EF4-FFF2-40B4-BE49-F238E27FC236}">
                          <a16:creationId xmlns:a16="http://schemas.microsoft.com/office/drawing/2014/main" xmlns="" id="{F59C9482-384A-4641-96F4-D050BE337FD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93266" y="4974580"/>
                      <a:ext cx="2441375" cy="36933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r>
                        <a:rPr lang="en-US" altLang="ja-JP" sz="1800" dirty="0">
                          <a:solidFill>
                            <a:srgbClr val="000000"/>
                          </a:solidFill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Osaki Citizen Hospital</a:t>
                      </a:r>
                      <a:endParaRPr lang="ja-JP" altLang="en-US" sz="1800" dirty="0">
                        <a:ea typeface="HG丸ｺﾞｼｯｸM-PRO" panose="020F06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409" name="正方形/長方形 15">
                      <a:extLst>
                        <a:ext uri="{FF2B5EF4-FFF2-40B4-BE49-F238E27FC236}">
                          <a16:creationId xmlns:a16="http://schemas.microsoft.com/office/drawing/2014/main" xmlns="" id="{7DF00A2F-E26B-4C67-B6B0-13D4A137E653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93266" y="4545261"/>
                      <a:ext cx="2775095" cy="3693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1pPr>
                      <a:lvl2pPr marL="742950" indent="-28575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2pPr>
                      <a:lvl3pPr marL="11430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3pPr>
                      <a:lvl4pPr marL="16002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4pPr>
                      <a:lvl5pPr marL="2057400" indent="-228600"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5pPr>
                      <a:lvl6pPr marL="25146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6pPr>
                      <a:lvl7pPr marL="29718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7pPr>
                      <a:lvl8pPr marL="34290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8pPr>
                      <a:lvl9pPr marL="3886200" indent="-2286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50" charset="-128"/>
                        </a:defRPr>
                      </a:lvl9pPr>
                    </a:lstStyle>
                    <a:p>
                      <a:r>
                        <a:rPr lang="en-US" altLang="ja-JP" sz="1800">
                          <a:solidFill>
                            <a:srgbClr val="000000"/>
                          </a:solidFill>
                          <a:ea typeface="HG丸ｺﾞｼｯｸM-PRO" panose="020F0600000000000000" pitchFamily="50" charset="-128"/>
                          <a:cs typeface="Arial" panose="020B0604020202020204" pitchFamily="34" charset="0"/>
                        </a:rPr>
                        <a:t>Kesennuma City Hospital</a:t>
                      </a:r>
                      <a:endParaRPr lang="ja-JP" altLang="en-US" sz="1800">
                        <a:ea typeface="HG丸ｺﾞｼｯｸM-PRO" panose="020F0600000000000000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8" name="直線コネクタ 17">
                      <a:extLst>
                        <a:ext uri="{FF2B5EF4-FFF2-40B4-BE49-F238E27FC236}">
                          <a16:creationId xmlns:a16="http://schemas.microsoft.com/office/drawing/2014/main" xmlns="" id="{3D4CFF9C-5AD9-45CD-8FE3-BBE8BCF18465}"/>
                        </a:ext>
                      </a:extLst>
                    </p:cNvPr>
                    <p:cNvCxnSpPr>
                      <a:stCxn id="16407" idx="1"/>
                    </p:cNvCxnSpPr>
                    <p:nvPr/>
                  </p:nvCxnSpPr>
                  <p:spPr>
                    <a:xfrm flipH="1">
                      <a:off x="4602954" y="4230898"/>
                      <a:ext cx="617457" cy="850898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" name="直線コネクタ 24">
                      <a:extLst>
                        <a:ext uri="{FF2B5EF4-FFF2-40B4-BE49-F238E27FC236}">
                          <a16:creationId xmlns:a16="http://schemas.microsoft.com/office/drawing/2014/main" xmlns="" id="{4C507AF7-A234-4D3C-B306-685873204A0E}"/>
                        </a:ext>
                      </a:extLst>
                    </p:cNvPr>
                    <p:cNvCxnSpPr>
                      <a:cxnSpLocks/>
                      <a:stCxn id="16409" idx="1"/>
                    </p:cNvCxnSpPr>
                    <p:nvPr/>
                  </p:nvCxnSpPr>
                  <p:spPr>
                    <a:xfrm flipH="1">
                      <a:off x="4871207" y="4729372"/>
                      <a:ext cx="422220" cy="430211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直線コネクタ 27">
                      <a:extLst>
                        <a:ext uri="{FF2B5EF4-FFF2-40B4-BE49-F238E27FC236}">
                          <a16:creationId xmlns:a16="http://schemas.microsoft.com/office/drawing/2014/main" xmlns="" id="{D0683ABC-BF0E-46F6-875D-7A4AF24E492A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4802953" y="3656225"/>
                      <a:ext cx="458728" cy="144462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" name="直線コネクタ 30">
                      <a:extLst>
                        <a:ext uri="{FF2B5EF4-FFF2-40B4-BE49-F238E27FC236}">
                          <a16:creationId xmlns:a16="http://schemas.microsoft.com/office/drawing/2014/main" xmlns="" id="{360FD658-9BC0-4FCF-8D75-5799233EDEFA}"/>
                        </a:ext>
                      </a:extLst>
                    </p:cNvPr>
                    <p:cNvCxnSpPr>
                      <a:stCxn id="16408" idx="1"/>
                    </p:cNvCxnSpPr>
                    <p:nvPr/>
                  </p:nvCxnSpPr>
                  <p:spPr>
                    <a:xfrm flipH="1">
                      <a:off x="4493431" y="5159246"/>
                      <a:ext cx="799835" cy="289261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" name="直線コネクタ 34">
                      <a:extLst>
                        <a:ext uri="{FF2B5EF4-FFF2-40B4-BE49-F238E27FC236}">
                          <a16:creationId xmlns:a16="http://schemas.microsoft.com/office/drawing/2014/main" xmlns="" id="{D1E20A6A-4A38-46F4-B357-B93C833B051C}"/>
                        </a:ext>
                      </a:extLst>
                    </p:cNvPr>
                    <p:cNvCxnSpPr>
                      <a:cxnSpLocks/>
                      <a:stCxn id="16400" idx="1"/>
                    </p:cNvCxnSpPr>
                    <p:nvPr/>
                  </p:nvCxnSpPr>
                  <p:spPr>
                    <a:xfrm flipH="1" flipV="1">
                      <a:off x="4461704" y="5551695"/>
                      <a:ext cx="728643" cy="426048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" name="直線コネクタ 37">
                      <a:extLst>
                        <a:ext uri="{FF2B5EF4-FFF2-40B4-BE49-F238E27FC236}">
                          <a16:creationId xmlns:a16="http://schemas.microsoft.com/office/drawing/2014/main" xmlns="" id="{ED0BD865-246B-4E3B-B63F-204C6CF9B09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558515" y="5733527"/>
                      <a:ext cx="746301" cy="172179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" name="直線コネクタ 43">
                      <a:extLst>
                        <a:ext uri="{FF2B5EF4-FFF2-40B4-BE49-F238E27FC236}">
                          <a16:creationId xmlns:a16="http://schemas.microsoft.com/office/drawing/2014/main" xmlns="" id="{C2078293-B09E-43DE-9159-D3567BAF26DB}"/>
                        </a:ext>
                      </a:extLst>
                    </p:cNvPr>
                    <p:cNvCxnSpPr>
                      <a:endCxn id="16402" idx="3"/>
                    </p:cNvCxnSpPr>
                    <p:nvPr/>
                  </p:nvCxnSpPr>
                  <p:spPr>
                    <a:xfrm flipH="1" flipV="1">
                      <a:off x="3569626" y="3984836"/>
                      <a:ext cx="831741" cy="1593846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直線コネクタ 46">
                      <a:extLst>
                        <a:ext uri="{FF2B5EF4-FFF2-40B4-BE49-F238E27FC236}">
                          <a16:creationId xmlns:a16="http://schemas.microsoft.com/office/drawing/2014/main" xmlns="" id="{2A94F783-BB31-4AC8-A3FC-CF9501C1B6A2}"/>
                        </a:ext>
                      </a:extLst>
                    </p:cNvPr>
                    <p:cNvCxnSpPr>
                      <a:endCxn id="16401" idx="3"/>
                    </p:cNvCxnSpPr>
                    <p:nvPr/>
                  </p:nvCxnSpPr>
                  <p:spPr>
                    <a:xfrm flipH="1" flipV="1">
                      <a:off x="3150581" y="4446798"/>
                      <a:ext cx="1236501" cy="982660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" name="直線コネクタ 51">
                      <a:extLst>
                        <a:ext uri="{FF2B5EF4-FFF2-40B4-BE49-F238E27FC236}">
                          <a16:creationId xmlns:a16="http://schemas.microsoft.com/office/drawing/2014/main" xmlns="" id="{1A81A7C7-EFBF-446B-A2DA-CF4D14DB5C5A}"/>
                        </a:ext>
                      </a:extLst>
                    </p:cNvPr>
                    <p:cNvCxnSpPr>
                      <a:stCxn id="16396" idx="1"/>
                    </p:cNvCxnSpPr>
                    <p:nvPr/>
                  </p:nvCxnSpPr>
                  <p:spPr>
                    <a:xfrm>
                      <a:off x="3169629" y="4869072"/>
                      <a:ext cx="1174597" cy="655635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直線コネクタ 54">
                      <a:extLst>
                        <a:ext uri="{FF2B5EF4-FFF2-40B4-BE49-F238E27FC236}">
                          <a16:creationId xmlns:a16="http://schemas.microsoft.com/office/drawing/2014/main" xmlns="" id="{3D4A330A-0800-4376-BD07-281E0F390869}"/>
                        </a:ext>
                      </a:extLst>
                    </p:cNvPr>
                    <p:cNvCxnSpPr/>
                    <p:nvPr/>
                  </p:nvCxnSpPr>
                  <p:spPr>
                    <a:xfrm flipH="1" flipV="1">
                      <a:off x="3661689" y="5429457"/>
                      <a:ext cx="442854" cy="80963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" name="直線コネクタ 58">
                      <a:extLst>
                        <a:ext uri="{FF2B5EF4-FFF2-40B4-BE49-F238E27FC236}">
                          <a16:creationId xmlns:a16="http://schemas.microsoft.com/office/drawing/2014/main" xmlns="" id="{3B8C5B97-DE42-4D82-A8E8-347E1DB1E8E2}"/>
                        </a:ext>
                      </a:extLst>
                    </p:cNvPr>
                    <p:cNvCxnSpPr>
                      <a:stCxn id="16406" idx="3"/>
                    </p:cNvCxnSpPr>
                    <p:nvPr/>
                  </p:nvCxnSpPr>
                  <p:spPr>
                    <a:xfrm>
                      <a:off x="3281775" y="6319775"/>
                      <a:ext cx="822769" cy="376504"/>
                    </a:xfrm>
                    <a:prstGeom prst="line">
                      <a:avLst/>
                    </a:prstGeom>
                    <a:ln w="12700"/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6394" name="正方形/長方形 11">
                  <a:extLst>
                    <a:ext uri="{FF2B5EF4-FFF2-40B4-BE49-F238E27FC236}">
                      <a16:creationId xmlns:a16="http://schemas.microsoft.com/office/drawing/2014/main" xmlns="" id="{99D3C003-1886-43D9-B5B1-10CBDA3965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25806" y="5431160"/>
                  <a:ext cx="2300634" cy="34163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defTabSz="685800">
                    <a:lnSpc>
                      <a:spcPct val="90000"/>
                    </a:lnSpc>
                    <a:spcBef>
                      <a:spcPts val="750"/>
                    </a:spcBef>
                    <a:buFont typeface="Arial" panose="020B0604020202020204" pitchFamily="34" charset="0"/>
                    <a:buChar char="•"/>
                    <a:defRPr kumimoji="1" sz="21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1pPr>
                  <a:lvl2pPr marL="742950" indent="-285750" defTabSz="685800">
                    <a:lnSpc>
                      <a:spcPct val="90000"/>
                    </a:lnSpc>
                    <a:spcBef>
                      <a:spcPts val="375"/>
                    </a:spcBef>
                    <a:buFont typeface="Arial" panose="020B0604020202020204" pitchFamily="34" charset="0"/>
                    <a:buChar char="•"/>
                    <a:defRPr kumimoji="1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2pPr>
                  <a:lvl3pPr marL="1143000" indent="-228600" defTabSz="685800">
                    <a:lnSpc>
                      <a:spcPct val="90000"/>
                    </a:lnSpc>
                    <a:spcBef>
                      <a:spcPts val="375"/>
                    </a:spcBef>
                    <a:buFont typeface="Arial" panose="020B0604020202020204" pitchFamily="34" charset="0"/>
                    <a:buChar char="•"/>
                    <a:defRPr kumimoji="1" sz="15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3pPr>
                  <a:lvl4pPr marL="1600200" indent="-228600" defTabSz="685800">
                    <a:lnSpc>
                      <a:spcPct val="90000"/>
                    </a:lnSpc>
                    <a:spcBef>
                      <a:spcPts val="375"/>
                    </a:spcBef>
                    <a:buFont typeface="Arial" panose="020B0604020202020204" pitchFamily="34" charset="0"/>
                    <a:buChar char="•"/>
                    <a:defRPr kumimoji="1" sz="13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4pPr>
                  <a:lvl5pPr marL="2057400" indent="-228600" defTabSz="685800">
                    <a:lnSpc>
                      <a:spcPct val="90000"/>
                    </a:lnSpc>
                    <a:spcBef>
                      <a:spcPts val="375"/>
                    </a:spcBef>
                    <a:buFont typeface="Arial" panose="020B0604020202020204" pitchFamily="34" charset="0"/>
                    <a:buChar char="•"/>
                    <a:defRPr kumimoji="1" sz="13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5pPr>
                  <a:lvl6pPr marL="2514600" indent="-228600" defTabSz="685800" eaLnBrk="0" fontAlgn="base" hangingPunct="0">
                    <a:lnSpc>
                      <a:spcPct val="90000"/>
                    </a:lnSpc>
                    <a:spcBef>
                      <a:spcPts val="375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 sz="13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6pPr>
                  <a:lvl7pPr marL="2971800" indent="-228600" defTabSz="685800" eaLnBrk="0" fontAlgn="base" hangingPunct="0">
                    <a:lnSpc>
                      <a:spcPct val="90000"/>
                    </a:lnSpc>
                    <a:spcBef>
                      <a:spcPts val="375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 sz="13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7pPr>
                  <a:lvl8pPr marL="3429000" indent="-228600" defTabSz="685800" eaLnBrk="0" fontAlgn="base" hangingPunct="0">
                    <a:lnSpc>
                      <a:spcPct val="90000"/>
                    </a:lnSpc>
                    <a:spcBef>
                      <a:spcPts val="375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 sz="13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8pPr>
                  <a:lvl9pPr marL="3886200" indent="-228600" defTabSz="685800" eaLnBrk="0" fontAlgn="base" hangingPunct="0">
                    <a:lnSpc>
                      <a:spcPct val="90000"/>
                    </a:lnSpc>
                    <a:spcBef>
                      <a:spcPts val="375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 kumimoji="1" sz="1300">
                      <a:solidFill>
                        <a:schemeClr val="tx1"/>
                      </a:solidFill>
                      <a:latin typeface="游ゴシック" panose="020B0400000000000000" pitchFamily="50" charset="-128"/>
                      <a:ea typeface="游ゴシック" panose="020B0400000000000000" pitchFamily="50" charset="-128"/>
                    </a:defRPr>
                  </a:lvl9pPr>
                </a:lstStyle>
                <a:p>
                  <a:pPr eaLnBrk="1" hangingPunct="1">
                    <a:buFontTx/>
                    <a:buNone/>
                  </a:pPr>
                  <a:r>
                    <a:rPr lang="en-US" altLang="ja-JP" sz="18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HG丸ｺﾞｼｯｸM-PRO" panose="020F0600000000000000" pitchFamily="50" charset="-128"/>
                      <a:cs typeface="Arial" panose="020B0604020202020204" pitchFamily="34" charset="0"/>
                    </a:rPr>
                    <a:t>Sen-</a:t>
                  </a:r>
                  <a:r>
                    <a:rPr lang="en-US" altLang="ja-JP" sz="1800" dirty="0" err="1">
                      <a:solidFill>
                        <a:srgbClr val="000000"/>
                      </a:solidFill>
                      <a:latin typeface="Arial" panose="020B0604020202020204" pitchFamily="34" charset="0"/>
                      <a:ea typeface="HG丸ｺﾞｼｯｸM-PRO" panose="020F0600000000000000" pitchFamily="50" charset="-128"/>
                      <a:cs typeface="Arial" panose="020B0604020202020204" pitchFamily="34" charset="0"/>
                    </a:rPr>
                    <a:t>en</a:t>
                  </a:r>
                  <a:r>
                    <a:rPr lang="en-US" altLang="ja-JP" sz="18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HG丸ｺﾞｼｯｸM-PRO" panose="020F0600000000000000" pitchFamily="50" charset="-128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800" dirty="0" err="1">
                      <a:solidFill>
                        <a:srgbClr val="000000"/>
                      </a:solidFill>
                      <a:latin typeface="Arial" panose="020B0604020202020204" pitchFamily="34" charset="0"/>
                      <a:ea typeface="HG丸ｺﾞｼｯｸM-PRO" panose="020F0600000000000000" pitchFamily="50" charset="-128"/>
                      <a:cs typeface="Arial" panose="020B0604020202020204" pitchFamily="34" charset="0"/>
                    </a:rPr>
                    <a:t>Rifu</a:t>
                  </a:r>
                  <a:r>
                    <a:rPr lang="en-US" altLang="ja-JP" sz="1800" dirty="0">
                      <a:solidFill>
                        <a:srgbClr val="000000"/>
                      </a:solidFill>
                      <a:latin typeface="Arial" panose="020B0604020202020204" pitchFamily="34" charset="0"/>
                      <a:ea typeface="HG丸ｺﾞｼｯｸM-PRO" panose="020F0600000000000000" pitchFamily="50" charset="-128"/>
                      <a:cs typeface="Arial" panose="020B0604020202020204" pitchFamily="34" charset="0"/>
                    </a:rPr>
                    <a:t> Hospital</a:t>
                  </a:r>
                </a:p>
              </p:txBody>
            </p:sp>
            <p:cxnSp>
              <p:nvCxnSpPr>
                <p:cNvPr id="37" name="直線コネクタ 36">
                  <a:extLst>
                    <a:ext uri="{FF2B5EF4-FFF2-40B4-BE49-F238E27FC236}">
                      <a16:creationId xmlns:a16="http://schemas.microsoft.com/office/drawing/2014/main" xmlns="" id="{7986BF28-03BA-4F76-93D1-8DECE7D7605F}"/>
                    </a:ext>
                  </a:extLst>
                </p:cNvPr>
                <p:cNvCxnSpPr/>
                <p:nvPr/>
              </p:nvCxnSpPr>
              <p:spPr bwMode="auto">
                <a:xfrm flipH="1" flipV="1">
                  <a:off x="4723396" y="5431734"/>
                  <a:ext cx="301626" cy="149225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391" name="正方形/長方形 8">
                <a:extLst>
                  <a:ext uri="{FF2B5EF4-FFF2-40B4-BE49-F238E27FC236}">
                    <a16:creationId xmlns:a16="http://schemas.microsoft.com/office/drawing/2014/main" xmlns="" id="{4529E7AF-C074-458A-8570-8854005EAF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1112" y="1618431"/>
                <a:ext cx="3155950" cy="369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742950" indent="-28575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r>
                  <a:rPr lang="en-US" altLang="ja-JP" sz="1800" b="1" dirty="0">
                    <a:solidFill>
                      <a:srgbClr val="000000"/>
                    </a:solidFill>
                    <a:ea typeface="HG丸ｺﾞｼｯｸM-PRO" panose="020F0600000000000000" pitchFamily="50" charset="-128"/>
                    <a:cs typeface="Arial" panose="020B0604020202020204" pitchFamily="34" charset="0"/>
                  </a:rPr>
                  <a:t>Tohoku University Hospital</a:t>
                </a:r>
                <a:endParaRPr lang="ja-JP" altLang="en-US" sz="1800" b="1" dirty="0">
                  <a:ea typeface="HG丸ｺﾞｼｯｸM-PRO" panose="020F0600000000000000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正方形/長方形 10">
              <a:extLst>
                <a:ext uri="{FF2B5EF4-FFF2-40B4-BE49-F238E27FC236}">
                  <a16:creationId xmlns:a16="http://schemas.microsoft.com/office/drawing/2014/main" xmlns="" id="{BFF94940-9EEE-62C1-2E5F-AD60AE6F5F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56895" y="5223531"/>
              <a:ext cx="3078792" cy="341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685800">
                <a:lnSpc>
                  <a:spcPct val="90000"/>
                </a:lnSpc>
                <a:spcBef>
                  <a:spcPts val="750"/>
                </a:spcBef>
                <a:buFont typeface="Arial" panose="020B0604020202020204" pitchFamily="34" charset="0"/>
                <a:buChar char="•"/>
                <a:defRPr kumimoji="1" sz="21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1pPr>
              <a:lvl2pPr marL="742950" indent="-285750" defTabSz="6858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kumimoji="1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2pPr>
              <a:lvl3pPr marL="1143000" indent="-228600" defTabSz="6858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kumimoji="1" sz="15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3pPr>
              <a:lvl4pPr marL="1600200" indent="-228600" defTabSz="6858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kumimoji="1" sz="13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4pPr>
              <a:lvl5pPr marL="2057400" indent="-228600" defTabSz="685800">
                <a:lnSpc>
                  <a:spcPct val="90000"/>
                </a:lnSpc>
                <a:spcBef>
                  <a:spcPts val="375"/>
                </a:spcBef>
                <a:buFont typeface="Arial" panose="020B0604020202020204" pitchFamily="34" charset="0"/>
                <a:buChar char="•"/>
                <a:defRPr kumimoji="1" sz="13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5pPr>
              <a:lvl6pPr marL="2514600" indent="-228600" defTabSz="6858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13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6pPr>
              <a:lvl7pPr marL="2971800" indent="-228600" defTabSz="6858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13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7pPr>
              <a:lvl8pPr marL="3429000" indent="-228600" defTabSz="6858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13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8pPr>
              <a:lvl9pPr marL="3886200" indent="-228600" defTabSz="685800" eaLnBrk="0" fontAlgn="base" hangingPunct="0">
                <a:lnSpc>
                  <a:spcPct val="90000"/>
                </a:lnSpc>
                <a:spcBef>
                  <a:spcPts val="375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 kumimoji="1" sz="1300">
                  <a:solidFill>
                    <a:schemeClr val="tx1"/>
                  </a:solidFill>
                  <a:latin typeface="游ゴシック" panose="020B0400000000000000" pitchFamily="50" charset="-128"/>
                  <a:ea typeface="游ゴシック" panose="020B0400000000000000" pitchFamily="50" charset="-128"/>
                </a:defRPr>
              </a:lvl9pPr>
            </a:lstStyle>
            <a:p>
              <a:pPr eaLnBrk="1" hangingPunct="1">
                <a:buFontTx/>
                <a:buNone/>
              </a:pPr>
              <a:r>
                <a:rPr lang="en-US" altLang="ja-JP" sz="1800" dirty="0">
                  <a:solidFill>
                    <a:srgbClr val="000000"/>
                  </a:solidFill>
                  <a:latin typeface="Arial" panose="020B0604020202020204" pitchFamily="34" charset="0"/>
                  <a:ea typeface="HG丸ｺﾞｼｯｸM-PRO" panose="020F0600000000000000" pitchFamily="50" charset="-128"/>
                  <a:cs typeface="Arial" panose="020B0604020202020204" pitchFamily="34" charset="0"/>
                </a:rPr>
                <a:t>KKR Tohoku Kosai Hospital</a:t>
              </a:r>
            </a:p>
          </p:txBody>
        </p:sp>
      </p:grp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F4F44C28-92E1-301E-38D3-F1EBDA9709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7720" y="5176322"/>
            <a:ext cx="1659214" cy="1659214"/>
          </a:xfrm>
          <a:prstGeom prst="rect">
            <a:avLst/>
          </a:prstGeom>
        </p:spPr>
      </p:pic>
      <p:sp>
        <p:nvSpPr>
          <p:cNvPr id="6" name="吹き出し: 線 5">
            <a:extLst>
              <a:ext uri="{FF2B5EF4-FFF2-40B4-BE49-F238E27FC236}">
                <a16:creationId xmlns:a16="http://schemas.microsoft.com/office/drawing/2014/main" xmlns="" id="{B829D5CB-0A5B-FC50-B4FC-76D1EA52201B}"/>
              </a:ext>
            </a:extLst>
          </p:cNvPr>
          <p:cNvSpPr/>
          <p:nvPr/>
        </p:nvSpPr>
        <p:spPr>
          <a:xfrm rot="16200000">
            <a:off x="2428068" y="-1204081"/>
            <a:ext cx="4228189" cy="8931099"/>
          </a:xfrm>
          <a:prstGeom prst="borderCallout1">
            <a:avLst>
              <a:gd name="adj1" fmla="val 47158"/>
              <a:gd name="adj2" fmla="val 1029"/>
              <a:gd name="adj3" fmla="val 21783"/>
              <a:gd name="adj4" fmla="val -13775"/>
            </a:avLst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0</TotalTime>
  <Words>56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HG丸ｺﾞｼｯｸM-PRO</vt:lpstr>
      <vt:lpstr>Office テーマ</vt:lpstr>
      <vt:lpstr>Thirteen regional hospitals and Tohoku University Hospital  in the east northern region of Japa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saki Yoshihide</dc:creator>
  <cp:lastModifiedBy>Chithra M.</cp:lastModifiedBy>
  <cp:revision>30</cp:revision>
  <dcterms:created xsi:type="dcterms:W3CDTF">2022-04-06T05:40:27Z</dcterms:created>
  <dcterms:modified xsi:type="dcterms:W3CDTF">2023-01-25T12:16:02Z</dcterms:modified>
</cp:coreProperties>
</file>